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43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ttmar Janssen" userId="70344527451028a5" providerId="LiveId" clId="{7DABF767-E48C-4E15-8436-843485640943}"/>
    <pc:docChg chg="undo redo custSel modSld">
      <pc:chgData name="Ottmar Janssen" userId="70344527451028a5" providerId="LiveId" clId="{7DABF767-E48C-4E15-8436-843485640943}" dt="2024-09-11T10:17:30.206" v="83" actId="2711"/>
      <pc:docMkLst>
        <pc:docMk/>
      </pc:docMkLst>
      <pc:sldChg chg="modSp mod">
        <pc:chgData name="Ottmar Janssen" userId="70344527451028a5" providerId="LiveId" clId="{7DABF767-E48C-4E15-8436-843485640943}" dt="2024-09-11T10:17:30.206" v="83" actId="2711"/>
        <pc:sldMkLst>
          <pc:docMk/>
          <pc:sldMk cId="1690145425" sldId="256"/>
        </pc:sldMkLst>
        <pc:spChg chg="mod">
          <ac:chgData name="Ottmar Janssen" userId="70344527451028a5" providerId="LiveId" clId="{7DABF767-E48C-4E15-8436-843485640943}" dt="2024-09-11T10:17:30.206" v="83" actId="2711"/>
          <ac:spMkLst>
            <pc:docMk/>
            <pc:sldMk cId="1690145425" sldId="256"/>
            <ac:spMk id="14" creationId="{00000000-0000-0000-0000-000000000000}"/>
          </ac:spMkLst>
        </pc:spChg>
      </pc:sldChg>
    </pc:docChg>
  </pc:docChgLst>
  <pc:docChgLst>
    <pc:chgData name="Ottmar Janssen" userId="70344527451028a5" providerId="LiveId" clId="{98F65BA8-7F3F-4D17-ABCF-DB2F6A2ECC67}"/>
    <pc:docChg chg="modSld">
      <pc:chgData name="Ottmar Janssen" userId="70344527451028a5" providerId="LiveId" clId="{98F65BA8-7F3F-4D17-ABCF-DB2F6A2ECC67}" dt="2024-10-16T13:34:04.032" v="1" actId="20577"/>
      <pc:docMkLst>
        <pc:docMk/>
      </pc:docMkLst>
      <pc:sldChg chg="modSp mod">
        <pc:chgData name="Ottmar Janssen" userId="70344527451028a5" providerId="LiveId" clId="{98F65BA8-7F3F-4D17-ABCF-DB2F6A2ECC67}" dt="2024-10-16T13:34:04.032" v="1" actId="20577"/>
        <pc:sldMkLst>
          <pc:docMk/>
          <pc:sldMk cId="1690145425" sldId="256"/>
        </pc:sldMkLst>
        <pc:spChg chg="mod">
          <ac:chgData name="Ottmar Janssen" userId="70344527451028a5" providerId="LiveId" clId="{98F65BA8-7F3F-4D17-ABCF-DB2F6A2ECC67}" dt="2024-10-16T13:34:04.032" v="1" actId="20577"/>
          <ac:spMkLst>
            <pc:docMk/>
            <pc:sldMk cId="1690145425" sldId="256"/>
            <ac:spMk id="14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040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921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825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7933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9918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3171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0342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6985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9527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8019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347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65742-871B-4910-90F1-B737E80639F0}" type="datetimeFigureOut">
              <a:rPr lang="en-GB" smtClean="0"/>
              <a:t>16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DC1744-B9E8-4B75-B849-815F6D0E639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5301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994" y="1207674"/>
            <a:ext cx="6192012" cy="408279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52462" y="5622030"/>
            <a:ext cx="55530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</a:t>
            </a:r>
            <a:r>
              <a:rPr lang="en-GB" sz="900" b="1">
                <a:latin typeface="Palatino Linotype" panose="02040502050505030304" pitchFamily="18" charset="0"/>
                <a:cs typeface="Arial" panose="020B0604020202020204" pitchFamily="34" charset="0"/>
              </a:rPr>
              <a:t>Figure S4 </a:t>
            </a:r>
            <a:r>
              <a:rPr lang="en-GB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– Histograms depicting the distribution of relative protein fold changes for log</a:t>
            </a:r>
            <a:r>
              <a:rPr lang="en-GB" sz="900" baseline="-25000" dirty="0">
                <a:latin typeface="Palatino Linotype" panose="02040502050505030304" pitchFamily="18" charset="0"/>
                <a:cs typeface="Arial" panose="020B0604020202020204" pitchFamily="34" charset="0"/>
              </a:rPr>
              <a:t>2</a:t>
            </a:r>
            <a:r>
              <a:rPr lang="en-GB" sz="900" dirty="0">
                <a:latin typeface="Palatino Linotype" panose="02040502050505030304" pitchFamily="18" charset="0"/>
                <a:cs typeface="Arial" panose="020B0604020202020204" pitchFamily="34" charset="0"/>
              </a:rPr>
              <a:t>(CD8</a:t>
            </a:r>
            <a:r>
              <a:rPr lang="en-GB" sz="9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Palatino Linotype" panose="02040502050505030304" pitchFamily="18" charset="0"/>
                <a:cs typeface="Arial" panose="020B0604020202020204" pitchFamily="34" charset="0"/>
              </a:rPr>
              <a:t>-EV/</a:t>
            </a:r>
            <a:r>
              <a:rPr lang="el-GR" sz="900" dirty="0">
                <a:latin typeface="Palatino Linotype" panose="02040502050505030304" pitchFamily="18" charset="0"/>
                <a:cs typeface="Arial" panose="020B0604020202020204" pitchFamily="34" charset="0"/>
              </a:rPr>
              <a:t>γδ</a:t>
            </a:r>
            <a:r>
              <a:rPr lang="en-GB" sz="900" dirty="0">
                <a:latin typeface="Palatino Linotype" panose="02040502050505030304" pitchFamily="18" charset="0"/>
                <a:cs typeface="Arial" panose="020B0604020202020204" pitchFamily="34" charset="0"/>
              </a:rPr>
              <a:t>-EV). Replicates are highlighted individually as (A) replicate 1, (B) replicate 2, (C) replicate 3, and (D) replicate 4. Notably, only 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replicate 4 showed a slightly different ratio calculation plot indicating high homogeneity of the prepared samples</a:t>
            </a:r>
            <a:r>
              <a:rPr lang="en-GB" sz="900" dirty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6901454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3</Words>
  <Application>Microsoft Office PowerPoint</Application>
  <PresentationFormat>A4-Papier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ick</dc:creator>
  <cp:lastModifiedBy>Ottmar Janssen</cp:lastModifiedBy>
  <cp:revision>6</cp:revision>
  <dcterms:created xsi:type="dcterms:W3CDTF">2024-09-04T12:04:04Z</dcterms:created>
  <dcterms:modified xsi:type="dcterms:W3CDTF">2024-10-16T13:34:05Z</dcterms:modified>
</cp:coreProperties>
</file>